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73814FB-B47F-C258-324D-4DC5A99089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27A93106-2046-DE02-4540-FA5D9373F5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290CC64D-8529-F4F4-C847-C0F40C760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76E9DFBB-5B3D-39A9-493F-3E774A2FE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8E4E12D-56F7-0950-D09F-DCF64CF08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80112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2061CEC-61F3-8017-D0DF-D9B8AD089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2F872675-16F8-3722-149E-CE90DD9697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A1395F2-8469-EB39-C7E2-488529E55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DC73AC77-14F6-B36F-5E6B-245E26C0B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62C31C6D-FD36-A9A8-9D97-3DC89714C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81979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D1A08056-B7AB-5D56-62F6-45357EDD27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C3963C7E-0F57-6F62-8C9B-AABB31E5C7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C69B4A4D-205C-D68F-51C4-9062BF209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B1D5C9A1-C85B-A77F-82F3-56FA1C163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7602A800-A49F-5A19-C335-D34883B9F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43210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863B389-8327-C246-63E7-9DDF9ACA3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FF5D7557-3D00-DD17-5E21-ED0DA30D60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7AAEBF33-647D-B953-45C7-509E017E5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56A0A70C-1D2F-AEE0-2FB3-2FC127453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BB9032B-95D9-EE7B-1C50-CC3A2D3ACA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92235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24C508B-0E18-D620-E922-C05E953BAD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60562DB7-9E94-6FBA-6A5E-7A9250ADC3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C93C6E6-48A7-73B1-105A-FB6E949E1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5AA25A2-3450-B4B3-0845-E7828828C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7F0D333-7FF9-F482-4B83-360427787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980915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604C0E7-67D8-B644-1BB3-928E364C10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6D757B47-8129-4B22-ABF0-9F4B3172D8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9880FBA4-7911-1DBB-25F9-73BFE8513D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FBE817BC-7DD0-D4C8-2029-41021913D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0EAFD3E1-D5F8-F994-EE29-D779E25C9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284A2569-098D-585E-7FC6-9EE7229FA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1918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ABEF495E-803D-979D-40EA-99E8641F9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D987B73B-10F9-A507-6765-4FA5E8120E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A1AEB969-4E94-E128-6028-5D76E9D15B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A9814F6C-E112-1189-D432-CDF6AD3222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5E843814-0F88-CE9A-9F0D-AC2D4D1E8B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A5C7ECEE-6733-E5DC-2014-E4CC23533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1120B910-3FF3-A312-ED93-997E64CAF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FB684CD2-DE43-003D-F86C-AC5B14E5F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45750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DAB055B-9FE1-73B0-7F2B-2A8AEB70E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7325B5D5-CFC4-9955-92C0-B10C06A6E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D26C8C02-7AC0-3FC0-D853-46901629E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CB8B5573-1B1A-E572-3993-D63A13D7FE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65543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BD100239-ADF2-9E48-6520-6F0D65125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604FD122-DE8D-4C2A-B616-B7B450F43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F7B2E313-B451-2992-63D8-D506B1E9B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180132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03189A4E-E148-3BC0-7E8A-5FD48701A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E9CE1F44-4CD0-46CB-EAFE-BCBB239236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35F493BF-2417-C168-C81C-DC8C737894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9F068565-8A46-F0C2-B17A-40D476BB7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BDD53232-C5B8-E8C2-504A-B82F062B9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E563AB96-8FA7-96A9-CCE2-1499767615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74826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F9539EE-5922-89AA-6A49-7D7D51F3C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D4320710-281F-D9FE-7008-3D37ABA6D5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C9A9DF09-404D-5C1B-672A-587D756FC4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7CAED19D-051A-44E1-B8D4-AE6A71CF2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AA51B12F-1CBF-B221-F622-56ECA085D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3FF9C2B2-404A-4DBD-73B6-4DAFBF585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32442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2C2A04D2-0891-F060-8E52-2EDBE59423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436CFDB9-A856-8BC8-6949-F5A986E95B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1198F55-C755-F437-3ED0-568C488D38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39E65-8CAD-48D5-9E4B-DEB7FED5AF76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8080EA83-EB29-E212-C2B1-E183ECD774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5BE92A3B-4ABC-52E4-0719-C04BC11048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A23C57-9281-44C9-937F-44A19AA7FA9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67625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รูปภาพ 1">
            <a:extLst>
              <a:ext uri="{FF2B5EF4-FFF2-40B4-BE49-F238E27FC236}">
                <a16:creationId xmlns:a16="http://schemas.microsoft.com/office/drawing/2014/main" id="{4259EF63-DF47-DA1A-D3EE-F0A2668E9D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1052" y="569343"/>
            <a:ext cx="4063978" cy="5719313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D9C7DDA9-5B23-526F-1041-CF8C71851225}"/>
              </a:ext>
            </a:extLst>
          </p:cNvPr>
          <p:cNvSpPr txBox="1"/>
          <p:nvPr/>
        </p:nvSpPr>
        <p:spPr>
          <a:xfrm>
            <a:off x="830292" y="1040714"/>
            <a:ext cx="3827972" cy="9283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Table S2 Compounds identified in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serratum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(Linn.) Moon (CSM) drying with hot air oven via positive electrospray ionization (ESI-) LC-MS analysis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489842057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9:40Z</dcterms:created>
  <dcterms:modified xsi:type="dcterms:W3CDTF">2026-02-22T09:20:44Z</dcterms:modified>
</cp:coreProperties>
</file>